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wmf" ContentType="image/x-wmf"/>
  <Override PartName="/ppt/media/image2.wmf" ContentType="image/x-wmf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media/image7.png" ContentType="image/png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15E4C-E6DD-414C-8C6A-85B709248D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98A28-B022-4185-904A-0AA5D3D3CE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59159-0044-480D-9883-E91B18D75A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EDBF8-B9B9-4F76-82C5-C8245EB0E8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AD894-1A27-45A3-9BA3-8BD19EBBAD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AA701-DB7E-400A-9639-15A0D06151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FEC37-893D-4075-AD64-F905295437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707D8-0C47-46D9-AFFF-CAA54C6724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8F1F1-5082-4831-99CE-3626CA759E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3E4BA-7B24-4035-AB6B-5F5A51E9C1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959B0-2D64-45BE-A31C-315971D49E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705FA-0758-42CA-9367-F59AE3D5DC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46B571-8202-444A-A34D-C6059FD4F26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package" Target="../embeddings/oleObject3.xlsx"/><Relationship Id="rId7" Type="http://schemas.openxmlformats.org/officeDocument/2006/relationships/image" Target="../media/image4.wmf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6.wmf"/><Relationship Id="rId5" Type="http://schemas.openxmlformats.org/officeDocument/2006/relationships/image" Target="../media/image7.png"/><Relationship Id="rId6" Type="http://schemas.openxmlformats.org/officeDocument/2006/relationships/package" Target="../embeddings/oleObject3.xlsx"/><Relationship Id="rId7" Type="http://schemas.openxmlformats.org/officeDocument/2006/relationships/image" Target="../media/image8.wmf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4240" y="6649920"/>
            <a:ext cx="184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ii) Parasite exposur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86760" y="4230720"/>
            <a:ext cx="125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i) Snail strai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88200" y="1868400"/>
            <a:ext cx="8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) Tissu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5120" y="1569960"/>
            <a:ext cx="184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) Biological Proces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333360" y="4548240"/>
          <a:ext cx="6095880" cy="19908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3360" y="4548240"/>
                    <a:ext cx="6095880" cy="1990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>
            <a:off x="5448240" y="4638600"/>
            <a:ext cx="885960" cy="571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5486400" y="4695840"/>
            <a:ext cx="88920" cy="954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5486400" y="4871880"/>
            <a:ext cx="88920" cy="95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5547960" y="462132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42 - 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547960" y="479736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32 - 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486400" y="5048280"/>
            <a:ext cx="88920" cy="954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548320" y="497376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17 - 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333360" y="2185920"/>
          <a:ext cx="6076800" cy="19526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33360" y="2185920"/>
                    <a:ext cx="6076800" cy="1952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"/>
          <p:cNvSpPr/>
          <p:nvPr/>
        </p:nvSpPr>
        <p:spPr>
          <a:xfrm>
            <a:off x="5067360" y="2276640"/>
            <a:ext cx="1247760" cy="771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5095800" y="2305080"/>
            <a:ext cx="88920" cy="954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5095800" y="2454120"/>
            <a:ext cx="88920" cy="954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148360" y="224640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ra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5147280" y="239724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aemocyte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095800" y="2604960"/>
            <a:ext cx="88920" cy="95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149800" y="2546280"/>
            <a:ext cx="59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eadfoo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095800" y="2754360"/>
            <a:ext cx="88920" cy="950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095800" y="2905200"/>
            <a:ext cx="88920" cy="9504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149800" y="2697120"/>
            <a:ext cx="109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aemopoietic orga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146920" y="2846520"/>
            <a:ext cx="60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otesti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333360" y="7000920"/>
          <a:ext cx="6114960" cy="1942920"/>
        </p:xfrm>
        <a:graphic>
          <a:graphicData uri="http://schemas.openxmlformats.org/presentationml/2006/ole">
            <p:oleObj progId="Excel.Sheet.12" r:id="rId6" spid="">
              <p:embed/>
              <p:pic>
                <p:nvPicPr>
                  <p:cNvPr id="68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333360" y="7000920"/>
                    <a:ext cx="6114960" cy="194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9" name=""/>
          <p:cNvSpPr/>
          <p:nvPr/>
        </p:nvSpPr>
        <p:spPr>
          <a:xfrm>
            <a:off x="5457960" y="7105680"/>
            <a:ext cx="885600" cy="409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495760" y="7162920"/>
            <a:ext cx="88920" cy="9504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495760" y="7343640"/>
            <a:ext cx="88920" cy="95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5556960" y="70880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os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5556960" y="7269120"/>
            <a:ext cx="82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nexpos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50760" y="671400"/>
            <a:ext cx="64738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Percentage distribution of gene ontologies for a) Biological processes and b) Molecular function by i) tissue type, ii) snail strain and iii) parasite exposure. R- schistosome-resistant strain, S – susceptible strain.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"/>
          <p:cNvSpPr/>
          <p:nvPr/>
        </p:nvSpPr>
        <p:spPr>
          <a:xfrm>
            <a:off x="36720" y="5592600"/>
            <a:ext cx="184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ii) Parasite exposur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39240" y="3192480"/>
            <a:ext cx="125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i) Snail strai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0680" y="611280"/>
            <a:ext cx="8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) Tissu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-33480" y="312840"/>
            <a:ext cx="183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) Molecular functio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79" name=""/>
          <p:cNvGraphicFramePr/>
          <p:nvPr/>
        </p:nvGraphicFramePr>
        <p:xfrm>
          <a:off x="181080" y="6064200"/>
          <a:ext cx="6505560" cy="1741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1080" y="6064200"/>
                    <a:ext cx="6505560" cy="174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5734080" y="6124680"/>
            <a:ext cx="885960" cy="40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5772240" y="6181560"/>
            <a:ext cx="88920" cy="954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5772240" y="6362640"/>
            <a:ext cx="88920" cy="95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5833080" y="61070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os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5833080" y="6288120"/>
            <a:ext cx="82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nexpos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86" name=""/>
          <p:cNvGraphicFramePr/>
          <p:nvPr/>
        </p:nvGraphicFramePr>
        <p:xfrm>
          <a:off x="181080" y="955800"/>
          <a:ext cx="6514920" cy="18079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81080" y="955800"/>
                    <a:ext cx="6514920" cy="1807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"/>
          <p:cNvSpPr/>
          <p:nvPr/>
        </p:nvSpPr>
        <p:spPr>
          <a:xfrm>
            <a:off x="5353200" y="1019160"/>
            <a:ext cx="1247760" cy="771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5381640" y="1047600"/>
            <a:ext cx="88920" cy="954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5381640" y="1197000"/>
            <a:ext cx="88920" cy="954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5434200" y="98892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ra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5433120" y="113976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aemocyte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5381640" y="1347840"/>
            <a:ext cx="88920" cy="950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5435640" y="1289160"/>
            <a:ext cx="59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eadfoo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5381640" y="1496880"/>
            <a:ext cx="88920" cy="954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381640" y="1647720"/>
            <a:ext cx="88920" cy="9540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5435640" y="1440000"/>
            <a:ext cx="109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aemopoietic orga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5432400" y="1589040"/>
            <a:ext cx="60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otesti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99" name=""/>
          <p:cNvGraphicFramePr/>
          <p:nvPr/>
        </p:nvGraphicFramePr>
        <p:xfrm>
          <a:off x="181080" y="3551400"/>
          <a:ext cx="6494400" cy="1868400"/>
        </p:xfrm>
        <a:graphic>
          <a:graphicData uri="http://schemas.openxmlformats.org/presentationml/2006/ole">
            <p:oleObj progId="Excel.Sheet.12" r:id="rId6" spid="">
              <p:embed/>
              <p:pic>
                <p:nvPicPr>
                  <p:cNvPr id="100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181080" y="3551400"/>
                    <a:ext cx="6494400" cy="1868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1" name=""/>
          <p:cNvSpPr/>
          <p:nvPr/>
        </p:nvSpPr>
        <p:spPr>
          <a:xfrm>
            <a:off x="5695920" y="3648240"/>
            <a:ext cx="885960" cy="571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5734080" y="3705120"/>
            <a:ext cx="88920" cy="954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5734080" y="3881520"/>
            <a:ext cx="88920" cy="950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795640" y="363060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42 - 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795640" y="380700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32 - 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734080" y="4057560"/>
            <a:ext cx="88920" cy="954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795640" y="398304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17 - 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22T08:49:11Z</dcterms:created>
  <dc:creator>annel</dc:creator>
  <dc:description/>
  <dc:language>en-US</dc:language>
  <cp:lastModifiedBy>annel</cp:lastModifiedBy>
  <dcterms:modified xsi:type="dcterms:W3CDTF">2006-10-25T08:13:36Z</dcterms:modified>
  <cp:revision>14</cp:revision>
  <dc:subject/>
  <dc:title>PowerPoint Presentation</dc:title>
</cp:coreProperties>
</file>